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96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채 승훈" initials="채승" lastIdx="1" clrIdx="0">
    <p:extLst>
      <p:ext uri="{19B8F6BF-5375-455C-9EA6-DF929625EA0E}">
        <p15:presenceInfo xmlns:p15="http://schemas.microsoft.com/office/powerpoint/2012/main" userId="3b19a5fd2d3d070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2EBCD8B-E471-46B3-8D79-9FE7849B09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4B81F75-235B-4D7F-A9ED-B8E39B959D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022AEA-CF8A-4625-9FCB-D170BE2C5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F98914A-ABDD-4DC9-B4B1-82774D165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764555-34C8-4FCD-87C2-17B15ECBA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2937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9C768AB-6307-480F-B7AF-9708F6A2AD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A3E0ABC-4508-4865-AF89-3B8F56CDE8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ACC45FF-3715-4B01-87B1-FCD0A1362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E201775-6702-4EE8-A266-79C70276B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BFE2FD-6E40-45A3-8749-1FEEE558A2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3186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23ED270-864A-4848-A3D8-9F2EF124B1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31809E1-32E7-486E-9AF4-74C8C92DC2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1D31A1E-A52A-4379-80AC-6BD887630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6EAD6D6-D6D5-47AF-8B61-6E2AAB817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73C951-009D-43A2-9075-85F52B3A5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7299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DB5A181-CA8A-4F6D-9337-E58E0AC7E6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467BFB2-F129-4F40-BEB3-76FF7D99FD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65C203-1D53-4FCD-9046-D9A814868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18454DF-F1A2-41F6-80F1-92A2194BA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3F45617-0576-444B-80E2-9CD24DAB0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0459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CBFA0B2-A260-48FC-B2A6-E7C5A4F77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FD93B52-3E14-4E54-8198-7ABD81DFC4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E45811D-2D9D-470C-93A5-68DA14D01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A041EC-CE12-4506-86EA-1BC815A992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1B990CE-ABC7-4709-A85C-1D862E9DC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1979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80D14B4-FAF3-45C3-B4B1-E2BBC4097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4FEBC8E-C22A-4CBB-BAAB-FE640E3104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D59E5D6-54CF-47B5-96BA-BAFA1932D4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525C155-277D-4332-91F2-F13DE89F9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6816CE3-4E89-4937-9765-65702C9A6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45EF2C8-EC5E-42D9-9033-BBDF42B08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532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4DE8B5-253E-4334-8ADC-ABCC060871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02E57AB-11D9-4686-89E2-5BE6544360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FC4A98D-F2D0-4076-BA87-160510EB4F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4ECEBBC-EA5E-4CE3-8935-FED4134968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0D819F43-6BE6-4F38-8266-9999C1ED49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F2D4BBF-F36E-4F1A-A216-0687C5183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2DCF316A-4E81-4615-88A8-A5AA6601F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A5A6281A-5575-468B-ABEA-867C638D7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9209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861EB0D-AC21-422B-9989-83B26708E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215C87BA-DB90-4212-8B0B-173E16306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122DC75C-D2D2-4999-A629-8DCAABFB7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3D9E0DA-C2D9-4365-A83A-EE13BDE69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3366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2B3D526D-C0E2-417D-94CE-D58439D81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3B926CC-8F88-4DC7-9D59-42D216EC3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1636EAA-170F-4370-BC83-33E594773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3097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F253B5C-D034-44D6-B53B-660E21EC9C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6A3CF46-A64C-4152-AE33-B5DD654499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20A15D8-A450-46CE-AE17-3A604B12BC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02F3442-DBC1-48AF-B9C2-345260F4A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FBC28AD-D74A-4E0C-B663-C85D78451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CAE2C1D-7113-4853-B807-4324637A0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0713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670996E-974C-4BEB-BCBD-5D14D800B5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4434CFC-E51D-4877-B892-5309DE2396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0145522-3DF1-4FDA-8EEE-E12DDC85D5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C4A265E-89C5-43FC-8A0C-51D79EA929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8B5A7ED-818D-4006-8217-92DD8BFC1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63E1243-5868-4ADB-97F0-E8D73A3DC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8353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E4373D9-C885-4046-87FB-39F6821584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B841836-A9B7-4070-89A1-E282D847BB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38DF224-63DA-42FD-8960-4313ABB6CE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6A2E3E-4C1C-4515-BE29-8FEA63F39616}" type="datetimeFigureOut">
              <a:rPr lang="ko-KR" altLang="en-US" smtClean="0"/>
              <a:t>2022-0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BD9BC5B-6D19-497E-AF66-67B3105FDB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2164602-992D-4A95-978C-396670278A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49BE5A-71D8-4513-9C5B-5DB0A6A6F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7816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27284" t="42963" r="626" b="30237"/>
          <a:stretch/>
        </p:blipFill>
        <p:spPr>
          <a:xfrm>
            <a:off x="357051" y="1393371"/>
            <a:ext cx="11077303" cy="23164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8221015-7FC2-4C29-AE49-12B672453E9E}"/>
              </a:ext>
            </a:extLst>
          </p:cNvPr>
          <p:cNvSpPr txBox="1"/>
          <p:nvPr/>
        </p:nvSpPr>
        <p:spPr>
          <a:xfrm>
            <a:off x="1166949" y="3030584"/>
            <a:ext cx="1062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4C79932-0A1E-4B72-8DE0-E5A63C03B7EC}"/>
              </a:ext>
            </a:extLst>
          </p:cNvPr>
          <p:cNvSpPr txBox="1"/>
          <p:nvPr/>
        </p:nvSpPr>
        <p:spPr>
          <a:xfrm>
            <a:off x="1306286" y="3030584"/>
            <a:ext cx="1062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2E046D-2E4E-4B56-B7E4-C95876424EA4}"/>
              </a:ext>
            </a:extLst>
          </p:cNvPr>
          <p:cNvSpPr txBox="1"/>
          <p:nvPr/>
        </p:nvSpPr>
        <p:spPr>
          <a:xfrm>
            <a:off x="5199017" y="1382988"/>
            <a:ext cx="1062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D6076D0-72E7-4C3D-8605-0D915E0D3519}"/>
              </a:ext>
            </a:extLst>
          </p:cNvPr>
          <p:cNvSpPr txBox="1"/>
          <p:nvPr/>
        </p:nvSpPr>
        <p:spPr>
          <a:xfrm>
            <a:off x="7367451" y="3011492"/>
            <a:ext cx="1062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7E88487-8855-414F-9A82-D9B29E33A85A}"/>
              </a:ext>
            </a:extLst>
          </p:cNvPr>
          <p:cNvSpPr txBox="1"/>
          <p:nvPr/>
        </p:nvSpPr>
        <p:spPr>
          <a:xfrm>
            <a:off x="1532708" y="3011493"/>
            <a:ext cx="1062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3(IS)</a:t>
            </a:r>
          </a:p>
        </p:txBody>
      </p:sp>
      <p:sp>
        <p:nvSpPr>
          <p:cNvPr id="9" name="내용 개체 틀 2">
            <a:extLst>
              <a:ext uri="{FF2B5EF4-FFF2-40B4-BE49-F238E27FC236}">
                <a16:creationId xmlns:a16="http://schemas.microsoft.com/office/drawing/2014/main" id="{B8804CA7-D9F5-47B0-B871-3F11F519EF16}"/>
              </a:ext>
            </a:extLst>
          </p:cNvPr>
          <p:cNvSpPr txBox="1">
            <a:spLocks/>
          </p:cNvSpPr>
          <p:nvPr/>
        </p:nvSpPr>
        <p:spPr>
          <a:xfrm>
            <a:off x="246017" y="3792001"/>
            <a:ext cx="10515600" cy="18286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800" b="1" dirty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 Figure S1.</a:t>
            </a:r>
            <a:r>
              <a:rPr lang="en-US" altLang="ko-KR" sz="1800" dirty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Chromatogram of glucosinolate from small-type radish root by HPLC. 1:Progoitirn, 2:Glucoraphanin, 3:Sinigrin(Internal Standard), 4:Glucoraphasatin, 5:Neoglucobrassicin. </a:t>
            </a:r>
            <a:endParaRPr lang="ko-KR" altLang="ko-KR" sz="18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69820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내용 개체 틀 2">
            <a:extLst>
              <a:ext uri="{FF2B5EF4-FFF2-40B4-BE49-F238E27FC236}">
                <a16:creationId xmlns:a16="http://schemas.microsoft.com/office/drawing/2014/main" id="{4877DCB1-5528-4207-81CC-793D69C3A72B}"/>
              </a:ext>
            </a:extLst>
          </p:cNvPr>
          <p:cNvSpPr txBox="1">
            <a:spLocks/>
          </p:cNvSpPr>
          <p:nvPr/>
        </p:nvSpPr>
        <p:spPr>
          <a:xfrm>
            <a:off x="106680" y="399677"/>
            <a:ext cx="12085320" cy="18286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800" b="1" dirty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 </a:t>
            </a:r>
            <a:r>
              <a:rPr lang="en-US" altLang="ko-KR" sz="1800" b="1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able S1</a:t>
            </a:r>
            <a:r>
              <a:rPr lang="en-US" altLang="ko-KR" sz="1800" b="1" dirty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</a:t>
            </a:r>
            <a:r>
              <a:rPr lang="en-US" altLang="ko-KR" sz="1800" dirty="0">
                <a:solidFill>
                  <a:srgbClr val="000000"/>
                </a:solidFill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ree glucosinolate concentrations of root of three different radish cultivars grown in spring and autumn 2020 </a:t>
            </a:r>
            <a:endParaRPr lang="ko-KR" altLang="en-US" dirty="0"/>
          </a:p>
        </p:txBody>
      </p:sp>
      <p:sp>
        <p:nvSpPr>
          <p:cNvPr id="21" name="내용 개체 틀 2">
            <a:extLst>
              <a:ext uri="{FF2B5EF4-FFF2-40B4-BE49-F238E27FC236}">
                <a16:creationId xmlns:a16="http://schemas.microsoft.com/office/drawing/2014/main" id="{0EE1E7F1-D3AB-4482-8520-BFD1CE9CE71D}"/>
              </a:ext>
            </a:extLst>
          </p:cNvPr>
          <p:cNvSpPr txBox="1">
            <a:spLocks/>
          </p:cNvSpPr>
          <p:nvPr/>
        </p:nvSpPr>
        <p:spPr>
          <a:xfrm>
            <a:off x="106680" y="4493622"/>
            <a:ext cx="12085320" cy="18286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fferent capital letters 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ide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number indicate significant differences among cultivars within the same season according to Tukey’s HSD test (</a:t>
            </a:r>
            <a:r>
              <a:rPr lang="en-US" altLang="ko-KR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5). 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맑은 고딕" panose="020B0503020000020004" pitchFamily="50" charset="-127"/>
                <a:ea typeface="Times New Roman" panose="02020603050405020304" pitchFamily="18" charset="0"/>
                <a:cs typeface="맑은 고딕" panose="020B0503020000020004" pitchFamily="50" charset="-127"/>
              </a:rPr>
              <a:t>A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risks (*) and </a:t>
            </a:r>
            <a:r>
              <a:rPr lang="en-US" altLang="ko-KR" sz="1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s side 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indicate significant differences between spring and autumn seasons within the same cultivar according to unpaired t-test (</a:t>
            </a:r>
            <a:r>
              <a:rPr lang="en-US" altLang="ko-KR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5). Total was indicated average of three cultivar radish. 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맑은 고딕" panose="020B0503020000020004" pitchFamily="50" charset="-127"/>
                <a:ea typeface="Times New Roman" panose="02020603050405020304" pitchFamily="18" charset="0"/>
                <a:cs typeface="맑은 고딕" panose="020B0503020000020004" pitchFamily="50" charset="-127"/>
              </a:rPr>
              <a:t>A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risks (*) side number indicate significant differences between spring and autumn seasons within the same </a:t>
            </a:r>
            <a:r>
              <a:rPr lang="en-US" altLang="ko-KR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ccording to unpaired t-test (</a:t>
            </a:r>
            <a:r>
              <a:rPr lang="en-US" altLang="ko-KR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5). </a:t>
            </a:r>
            <a:endParaRPr lang="ko-KR" altLang="en-US" dirty="0"/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A1665773-E016-4606-A616-0508212522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5968530"/>
              </p:ext>
            </p:extLst>
          </p:nvPr>
        </p:nvGraphicFramePr>
        <p:xfrm>
          <a:off x="960100" y="1386930"/>
          <a:ext cx="9951740" cy="2645135"/>
        </p:xfrm>
        <a:graphic>
          <a:graphicData uri="http://schemas.openxmlformats.org/drawingml/2006/table">
            <a:tbl>
              <a:tblPr firstRow="1" firstCol="1" bandRow="1"/>
              <a:tblGrid>
                <a:gridCol w="1516919">
                  <a:extLst>
                    <a:ext uri="{9D8B030D-6E8A-4147-A177-3AD203B41FA5}">
                      <a16:colId xmlns:a16="http://schemas.microsoft.com/office/drawing/2014/main" val="665183823"/>
                    </a:ext>
                  </a:extLst>
                </a:gridCol>
                <a:gridCol w="1726252">
                  <a:extLst>
                    <a:ext uri="{9D8B030D-6E8A-4147-A177-3AD203B41FA5}">
                      <a16:colId xmlns:a16="http://schemas.microsoft.com/office/drawing/2014/main" val="3628201724"/>
                    </a:ext>
                  </a:extLst>
                </a:gridCol>
                <a:gridCol w="2392938">
                  <a:extLst>
                    <a:ext uri="{9D8B030D-6E8A-4147-A177-3AD203B41FA5}">
                      <a16:colId xmlns:a16="http://schemas.microsoft.com/office/drawing/2014/main" val="1504949811"/>
                    </a:ext>
                  </a:extLst>
                </a:gridCol>
                <a:gridCol w="2392938">
                  <a:extLst>
                    <a:ext uri="{9D8B030D-6E8A-4147-A177-3AD203B41FA5}">
                      <a16:colId xmlns:a16="http://schemas.microsoft.com/office/drawing/2014/main" val="2239165384"/>
                    </a:ext>
                  </a:extLst>
                </a:gridCol>
                <a:gridCol w="1922693">
                  <a:extLst>
                    <a:ext uri="{9D8B030D-6E8A-4147-A177-3AD203B41FA5}">
                      <a16:colId xmlns:a16="http://schemas.microsoft.com/office/drawing/2014/main" val="746220789"/>
                    </a:ext>
                  </a:extLst>
                </a:gridCol>
              </a:tblGrid>
              <a:tr h="338549"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µmole/g DW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rogoitrin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lucoraphanin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eoglucobrassicin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1640332"/>
                  </a:ext>
                </a:extLst>
              </a:tr>
              <a:tr h="238944">
                <a:tc rowSpan="4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  <a:p>
                      <a:pPr indent="69850"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pring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aeyang 1ho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3 ± 0.01 B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9 ± 0.06 A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1 ± 0.03 A*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4754372"/>
                  </a:ext>
                </a:extLst>
              </a:tr>
              <a:tr h="23894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52949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2 ± 0.11 ABns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5 ± 0.01 A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4 ± 0.01 Bns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396299"/>
                  </a:ext>
                </a:extLst>
              </a:tr>
              <a:tr h="23894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50704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6 ± 0.01 A 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5 ± 0.00 Ans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1 ± 0.01 B*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2592822"/>
                  </a:ext>
                </a:extLst>
              </a:tr>
              <a:tr h="31057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verage</a:t>
                      </a:r>
                      <a:endParaRPr lang="ko-KR" sz="1100" b="1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97 </a:t>
                      </a: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± 0.06 ns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3 </a:t>
                      </a: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± 0.03 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5 </a:t>
                      </a: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± 0.01 ns 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5928660"/>
                  </a:ext>
                </a:extLst>
              </a:tr>
              <a:tr h="238944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100" b="1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8756771"/>
                  </a:ext>
                </a:extLst>
              </a:tr>
              <a:tr h="238944">
                <a:tc rowSpan="4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utumn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aeyang 1ho</a:t>
                      </a:r>
                      <a:endParaRPr lang="ko-KR" sz="1100" b="1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21 ± 0.08 A*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0 ± 0.02 A*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8 ± 0.01 A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9752964"/>
                  </a:ext>
                </a:extLst>
              </a:tr>
              <a:tr h="23894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52949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0 ± 0.04 Bns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1 ± 0.00 A*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0 ± 0.03 Ans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6964961"/>
                  </a:ext>
                </a:extLst>
              </a:tr>
              <a:tr h="23894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50704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6 ± 0.00 AB*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6 ± 0.07 Ans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6 ± 0.00 A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2529934"/>
                  </a:ext>
                </a:extLst>
              </a:tr>
              <a:tr h="32340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verage</a:t>
                      </a:r>
                      <a:endParaRPr lang="ko-KR" sz="110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2 </a:t>
                      </a: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± 0.04 ns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62 </a:t>
                      </a:r>
                      <a:r>
                        <a:rPr lang="en-US" sz="1400" b="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± 0.03 *</a:t>
                      </a:r>
                      <a:endParaRPr lang="ko-KR" sz="1100" b="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8 </a:t>
                      </a:r>
                      <a:r>
                        <a:rPr lang="en-US" sz="1400" b="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± 0.02 ns</a:t>
                      </a:r>
                      <a:endParaRPr lang="ko-KR" sz="1100" b="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22119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3613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7</TotalTime>
  <Words>279</Words>
  <Application>Microsoft Office PowerPoint</Application>
  <PresentationFormat>Widescreen</PresentationFormat>
  <Paragraphs>5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Palatino Linotype</vt:lpstr>
      <vt:lpstr>Times New Roman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채 승훈</dc:creator>
  <cp:lastModifiedBy>MDPI</cp:lastModifiedBy>
  <cp:revision>22</cp:revision>
  <dcterms:created xsi:type="dcterms:W3CDTF">2021-11-03T08:28:17Z</dcterms:created>
  <dcterms:modified xsi:type="dcterms:W3CDTF">2022-01-25T06:24:43Z</dcterms:modified>
</cp:coreProperties>
</file>